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3333F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0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21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8939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581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899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5970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912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5889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2155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948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8742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8576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5275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3D2DB5-47AF-4DA0-98D2-6B0B9B7AC6B0}" type="datetimeFigureOut">
              <a:rPr lang="ko-KR" altLang="en-US" smtClean="0"/>
              <a:t>2023-11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A2FEE6-4E99-4D39-9C3C-90897D1BA81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2671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A1F2D0C8-482B-4967-A718-AA9889E295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155" y="8039526"/>
            <a:ext cx="6547510" cy="969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ko-KR" sz="12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en-US" altLang="ko-KR" sz="12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 ACC </a:t>
            </a:r>
            <a:r>
              <a:rPr kumimoji="0" lang="en-US" altLang="ko-KR" sz="1200" b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enes of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. </a:t>
            </a:r>
            <a:r>
              <a:rPr kumimoji="0" lang="en-US" altLang="ko-KR" sz="120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obus</a:t>
            </a:r>
            <a:r>
              <a:rPr kumimoji="0" lang="en-US" altLang="ko-KR" sz="120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ogether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 other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inus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pecies contain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served G-box motif 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ACGTG)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 ATG sequences in blue box is the start codon of ACC genes and CACGTG sequences in red box is G-box motif in sequences of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inus </a:t>
            </a:r>
            <a:r>
              <a:rPr kumimoji="0" lang="en-US" altLang="ko-KR" sz="12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trobus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GIIE01072535.1),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inus </a:t>
            </a:r>
            <a:r>
              <a:rPr kumimoji="0" lang="en-US" altLang="ko-KR" sz="1200" b="0" i="1" u="none" strike="noStrike" cap="none" normalizeH="0" baseline="0" dirty="0" err="1">
                <a:ln>
                  <a:noFill/>
                </a:ln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ylvestris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HKW01001418.1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inus </a:t>
            </a:r>
            <a:r>
              <a:rPr kumimoji="0" lang="en-US" altLang="ko-KR" sz="1200" b="0" i="1" u="none" strike="noStrike" cap="none" normalizeH="0" baseline="0" dirty="0" err="1">
                <a:ln>
                  <a:noFill/>
                </a:ln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eda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44444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IYS01055253.1),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inus cembra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HAMI01036161.1),  and 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inus </a:t>
            </a:r>
            <a:r>
              <a:rPr kumimoji="0" lang="en-US" altLang="ko-KR" sz="1200" b="0" i="1" u="none" strike="noStrike" cap="none" normalizeH="0" baseline="0" dirty="0" err="1">
                <a:ln>
                  <a:noFill/>
                </a:ln>
                <a:solidFill>
                  <a:srgbClr val="21212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lexilis</a:t>
            </a:r>
            <a:r>
              <a:rPr kumimoji="0" lang="en-US" altLang="ko-KR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GHWE01083655.1)</a:t>
            </a:r>
            <a:r>
              <a:rPr kumimoji="0" lang="en-US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A9985D0-47B4-4EAD-A622-2E6BD53184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75707" y="475050"/>
            <a:ext cx="5721729" cy="77098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robus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AACAAGGAAGAGATGGTGCTGATGATGTTGTGGGTGACGCTGTAGC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G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CT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eda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AACAGGGAAGAGATGGTGCTGATGATATTGTGGGTGACGCTGTAGC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G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CT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mbra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AACAAGGAAGAGATGGTGCTGATGATGTTGTGGGTGACGCTGTAGC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G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C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AACAAGGAAGAGATGGTGCTGATGATATTGTGAGCGACGCTGTAGC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G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C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AACAAGGAAGAGATGGTGCTGATGATGTTGTGGGTGACGCTGTAGC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CG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CT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 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*.*********************.*****.* ************************ 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robus</a:t>
            </a:r>
            <a:r>
              <a:rPr lang="en-US" altLang="ko-KR" sz="9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TAATGGTCTTCCAGTCTTCTTTAATGTTCTCGCCGCCCCTGTCCAAATCCCAGTA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TAATAGTCTTACAGTCCTCATTAATGTTCTCACCGTCCGCGTCCAAATCCCAGTA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TAATGGTCTTCCAGTCTTCTTTAATGTTCTCGCCGCCCCTGTCCAAATCCCAGTA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TAATAGTCTTACAGTCCTCATTAATGTTCTCACCGCCCGCGTCCAAATCCCAGTA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CCTAATGGTCTTCCAGTCTTCTTTAATGTTCTCGCCGCCCCTGTCCAAATCCCAGTAAA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***.*****.***** **:***********.*** **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*************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trobu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TCTTC-------------------------CATGTTGCATTGGTGTGGACTCTTC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TCTG--------------------------AATATTGCATTGGTGTGGTCTATTC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TCTTCCATGTTGCATTGGCGTGGACTCTTCCATATTGCATTGGTGTGGACTCTTC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TCTG--------------------------AATATTGTATTGGTGTGGTCTATTC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GCAATCTTCCATGTTGCATTGGTGTGGACTCTTCCATATTGCATTGGTGTGGACTCTTC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****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**.*** **********:**.*** 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trobu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GCCTTGCATCTCGAATTGATTTGTTCTAATCCTTCTAAGAAACTCAGAGACAGCTT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GCCTTGCATCTCGGATTGATTTGTTCTAATCCTTCTAATAAAACCATAGACAGCCT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GCCTTGCATCTCGAATTGATTTGTTCTAATCCTTCTAAGAAACTCAGAGACAACTT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GCCTTGCATCTCGGATTGATTTGTTCTAATCCTTCTAATAAACCCAGAGACAGCCT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TGCCTTGCATCTCGAATTGATTTGTTCTAATCCTTCTAAGAAACTCAGAGACAGCTTT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************.************************ ***. ** *****.* **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trobu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GGTAGAGAGATTGCAGAGACAGCTTTCCAGGTAGAGAGATTGCCGGGGGATCTCTC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G-----------------------------GTAGAGAGATTGCAGGGGGATCTCTC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GGTAGAGAGATTGCAGAGACAGCTTTCCAGGTAGAGAGATTGCCGGGGGATCTCTC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CAG-----------------------------GTAGAGAGATTGCAGGGGGATCTCTG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GGTAGAGAGATTGCAGAGACAGCTTTCCAGGTAGAGAGATTGCCGGGGGATCTCTCA 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ko-KR" sz="9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***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                    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*********.*********** * 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trobu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TCTCTGAGGGGCGTAATCGCATTGG-------GTTTATTAGGTGGTCTGGAAATTG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TCTCGGAAGGGTGTAATCGCATTGGGCTTATTGTTCATTGGGTGGTCTGCAAATTG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TCTCTGAGGGGCGTAATCGCATTGGGCTTATT-------AGGTGGTCTGGAAATTG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TCTGGGAGGGGTGTAATCGCATTGGGCTTATTGTTCATTAGGTGGTCTGCAAATTGAA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TCTCTGAGGGGCGTAATCGCATTGG-------GCTAATTAGGTGGTCTGGAAATTGAA 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ko-KR" sz="900" dirty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 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.*** *************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            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********* ******** </a:t>
            </a:r>
            <a:endParaRPr kumimoji="0" lang="en-US" altLang="ko-KR" sz="9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trobu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AACTTTATTGCTTCGTAGGTGTTCTGCAAATTGAACCTTCCTCTCAGTTGAGGGGCG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ACCTTTATTGCTACTTAGGTGGTCTGCAAATTGAACCTTCCTCTCAGTTGAGGGGCG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AACTTTATTGCTTCGTAGGTGGTCTGCAAATTGAACCTTCCTCTCAGTTGAGGGGCG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ACCTTTATTGCTACTTAGGTGGTCTACAAATTGAACCTTCCTCTCAGTTGAGGGGCG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CAAACTTTATTGCTTCGTAGGTGGTCTGCTAATTGAACCTTCCTCTCAGTTGAGGGGCG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.**********:* ****** ***.*:*****************************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trobu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GAAATCTGCTGGTTTTAAGGTGTCTTAGGAAATAACAAATACAAT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GAAGG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GAAGTCTGCTGGTTTTAAGGTGTCTTAGGAAATAACAAAGATAAT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GAAGG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GAAGTCTGCTGGTTTTAAGGTGTCTTAGGAAATAACAAATACAAT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GAAGG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GAAGTCTGCTGGTTTTAAGGTGTCTTAGGAAATAACAAAGATAAT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GAAGG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CAGAAGTCTGCTGGTTTTAAGGTGTCTTAGGAAATAACAAATACAGT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FF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G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GGGAAGGT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**.*********************************** * *.*************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trobu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CCACACTAATGGGATTGCAAATGGGAAGGCTGCAGTGAGGACTTCAGCAGTTTTATC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taed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CCACACTAATGGGATTGCAAATGGGAAGGCTGCAGTGAGGACTTCAGCAGTTTTATC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cembra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CCCCACTAATGGGATTGCAAATGGGAAGGCTGCAGTGAGGACTTCAGCAGTTTTATC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sylvestr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CCACACTAATGGGATTGCAAATGGGAAGGCTGCAGTGAGGACTTCAGCAGCTTTATCT </a:t>
            </a:r>
            <a:r>
              <a:rPr kumimoji="0" lang="ko-KR" altLang="ko-KR" sz="9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.flexilis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TCCACACTAATGGGATTGCAAATGGGAAGGCTGCAGTGAGGACTTCAGCAGTTTTATCT </a:t>
            </a:r>
            <a:r>
              <a:rPr kumimoji="0" lang="en-US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kumimoji="0" lang="ko-KR" altLang="ko-KR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***.*********************************************** *******</a:t>
            </a:r>
            <a:r>
              <a:rPr kumimoji="0" lang="ko-KR" altLang="ko-KR" sz="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ko-KR" altLang="ko-K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A05C1652-99F7-424A-BFFB-E0CACDE89794}"/>
              </a:ext>
            </a:extLst>
          </p:cNvPr>
          <p:cNvSpPr/>
          <p:nvPr/>
        </p:nvSpPr>
        <p:spPr>
          <a:xfrm>
            <a:off x="5237882" y="588420"/>
            <a:ext cx="401983" cy="746540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7A075D-4737-456A-9733-310917958C83}"/>
              </a:ext>
            </a:extLst>
          </p:cNvPr>
          <p:cNvSpPr txBox="1"/>
          <p:nvPr/>
        </p:nvSpPr>
        <p:spPr>
          <a:xfrm>
            <a:off x="5176040" y="336550"/>
            <a:ext cx="561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G-box</a:t>
            </a:r>
            <a:endParaRPr lang="ko-KR" altLang="en-US" sz="1200" dirty="0"/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A1E6445A-4446-4266-A90F-A7091C596651}"/>
              </a:ext>
            </a:extLst>
          </p:cNvPr>
          <p:cNvSpPr/>
          <p:nvPr/>
        </p:nvSpPr>
        <p:spPr>
          <a:xfrm>
            <a:off x="5138490" y="6386241"/>
            <a:ext cx="240748" cy="691323"/>
          </a:xfrm>
          <a:prstGeom prst="rect">
            <a:avLst/>
          </a:prstGeom>
          <a:noFill/>
          <a:ln w="635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2255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08</TotalTime>
  <Words>360</Words>
  <Application>Microsoft Office PowerPoint</Application>
  <PresentationFormat>화면 슬라이드 쇼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Courier New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YE CHOI</cp:lastModifiedBy>
  <cp:revision>31</cp:revision>
  <dcterms:created xsi:type="dcterms:W3CDTF">2023-06-12T08:38:22Z</dcterms:created>
  <dcterms:modified xsi:type="dcterms:W3CDTF">2023-11-22T06:22:49Z</dcterms:modified>
</cp:coreProperties>
</file>